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649"/>
    <p:restoredTop sz="94694"/>
  </p:normalViewPr>
  <p:slideViewPr>
    <p:cSldViewPr snapToGrid="0" snapToObjects="1">
      <p:cViewPr varScale="1">
        <p:scale>
          <a:sx n="117" d="100"/>
          <a:sy n="117" d="100"/>
        </p:scale>
        <p:origin x="67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182129C-A24E-8C47-8AC8-F548635548E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99E6AF5-41B6-9347-AEFF-2168FC24573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9B940BB-3143-A945-9A7E-EE38E94F02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89EA3-1997-D14F-BA7B-099BDA31E9DE}" type="datetimeFigureOut">
              <a:rPr kumimoji="1" lang="ja-JP" altLang="en-US" smtClean="0"/>
              <a:t>2024/2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3FCEB8A-5208-4F45-B262-191B8E7386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629414B-5046-EC4B-85F9-70C620F559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4CB2B-2296-D243-A6D7-AE7DEE240A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92015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8C75E39-BC23-7F44-A5C2-B25238D423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B157BD6-0BCB-154B-8E40-C7250769C2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B70E541-05B5-CD4F-A970-2579ABCA79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89EA3-1997-D14F-BA7B-099BDA31E9DE}" type="datetimeFigureOut">
              <a:rPr kumimoji="1" lang="ja-JP" altLang="en-US" smtClean="0"/>
              <a:t>2024/2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55C81C7-279A-3E46-9F35-BFEC231C89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35C4F38-347D-D045-95B6-F611BAD967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4CB2B-2296-D243-A6D7-AE7DEE240A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91886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41281C9-C3AF-2546-A247-9D5B6D0806D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F736746-0901-5241-8722-E5676070B4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3221C15-8413-C143-9253-0D8E2D1E75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89EA3-1997-D14F-BA7B-099BDA31E9DE}" type="datetimeFigureOut">
              <a:rPr kumimoji="1" lang="ja-JP" altLang="en-US" smtClean="0"/>
              <a:t>2024/2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808FBF3-1DAA-3045-BCAD-21B316BF3D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7680492-D934-4F47-8253-2D226FDF33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4CB2B-2296-D243-A6D7-AE7DEE240A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26302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30E4946-CDC1-944A-83A1-6926605DF9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98523E1-9145-7F4F-845B-2400CE70049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B8A4BF9-2DE3-134D-B77B-A177F6A0C4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89EA3-1997-D14F-BA7B-099BDA31E9DE}" type="datetimeFigureOut">
              <a:rPr kumimoji="1" lang="ja-JP" altLang="en-US" smtClean="0"/>
              <a:t>2024/2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8A69BF9-3674-FF46-828A-5B88DB1567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AC075E6-C941-6A4F-8B18-B5311B04AA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4CB2B-2296-D243-A6D7-AE7DEE240A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7186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84C91BF-D138-654F-BD2C-60A62A8701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D030BCE-EC0E-AB4F-923E-A15726CF6C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2A1F94F-24C9-5847-A443-354D826C08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89EA3-1997-D14F-BA7B-099BDA31E9DE}" type="datetimeFigureOut">
              <a:rPr kumimoji="1" lang="ja-JP" altLang="en-US" smtClean="0"/>
              <a:t>2024/2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7A98EBF-39FE-CC46-B9FB-0A190D4354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FABF552-54FD-CA47-8220-7DCBB574D8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4CB2B-2296-D243-A6D7-AE7DEE240A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84949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74881AB-6B71-744A-8508-FD65C67B05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4569FEB-7ECB-7F4D-BEC1-69488D8B5DA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E52D78B-147B-D140-BDDC-6504DD1A1D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8C5940F-53B0-BA42-88C8-076A434F16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89EA3-1997-D14F-BA7B-099BDA31E9DE}" type="datetimeFigureOut">
              <a:rPr kumimoji="1" lang="ja-JP" altLang="en-US" smtClean="0"/>
              <a:t>2024/2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D05E976-AC25-F048-A1E5-4F6F2AD905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987955E-CE85-6B4A-9DAF-29ABD8908F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4CB2B-2296-D243-A6D7-AE7DEE240A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59413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6A0C907-AD65-6D4E-8284-64720B3CC4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BD11A6D-F712-8C46-93B3-E67F330CA9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066ABEB-2321-2C4E-8F12-E22985CE1F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A50CB132-0FF4-6942-900B-928DB350231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73B69ED-DFFD-184B-851C-F17A3A0BE97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D070986-C951-8A4A-AD7E-6114A9ACE8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89EA3-1997-D14F-BA7B-099BDA31E9DE}" type="datetimeFigureOut">
              <a:rPr kumimoji="1" lang="ja-JP" altLang="en-US" smtClean="0"/>
              <a:t>2024/2/1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689A54F8-BA85-744A-9A7D-735AE411CD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C2A233E-9AE8-734A-9EC3-9C5C669471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4CB2B-2296-D243-A6D7-AE7DEE240A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7051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ECC761B-A46F-4E49-98FE-30529C7758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0F5E1AFA-4541-0043-A294-122BAFF88F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89EA3-1997-D14F-BA7B-099BDA31E9DE}" type="datetimeFigureOut">
              <a:rPr kumimoji="1" lang="ja-JP" altLang="en-US" smtClean="0"/>
              <a:t>2024/2/1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D07CA0AB-8ECC-904A-B9BE-0272EE9CC7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447C2568-6EE1-6740-88C2-89D2C60C68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4CB2B-2296-D243-A6D7-AE7DEE240A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21918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58018183-3EA6-1443-BE43-0904A23333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89EA3-1997-D14F-BA7B-099BDA31E9DE}" type="datetimeFigureOut">
              <a:rPr kumimoji="1" lang="ja-JP" altLang="en-US" smtClean="0"/>
              <a:t>2024/2/1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3F51526F-C0D9-4443-88EC-63E95BC677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C200591E-972F-EA43-9F52-1D4C4AD084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4CB2B-2296-D243-A6D7-AE7DEE240A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96737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28CBE35-117C-2D49-98B2-803C2BA96C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49D06F7-558C-7046-A6E4-534CE561681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6A693AE-B7E0-F64F-B654-21285D60C8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16287BB-7E91-3244-91DF-A18D24BB8A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89EA3-1997-D14F-BA7B-099BDA31E9DE}" type="datetimeFigureOut">
              <a:rPr kumimoji="1" lang="ja-JP" altLang="en-US" smtClean="0"/>
              <a:t>2024/2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8ADE669-8A1B-5E41-A612-53F4F8B7AB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543D9D5-3285-BF4D-B675-3AFAABE65E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4CB2B-2296-D243-A6D7-AE7DEE240A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52232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55C9BB2-41DD-5E4B-A1F5-EB44EFF5B1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10499EF-F93E-434D-A79B-400CB7D5123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F9776C3-DE56-4C46-AEA9-A9AD30A7AC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281D88F-5630-9840-B7A9-27A6A3B340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89EA3-1997-D14F-BA7B-099BDA31E9DE}" type="datetimeFigureOut">
              <a:rPr kumimoji="1" lang="ja-JP" altLang="en-US" smtClean="0"/>
              <a:t>2024/2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9FB6290-12D6-3241-BB24-748AD0FCDA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96C1B2B-7E06-0444-838A-EDF91CAC51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4CB2B-2296-D243-A6D7-AE7DEE240A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93703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066A8D5-0D4F-D54E-9573-B6E19873DF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AC0F11F-C568-8E4C-8393-1BA25CD65B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6E4F65A-29B4-014E-8999-162C9FD1AB3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B89EA3-1997-D14F-BA7B-099BDA31E9DE}" type="datetimeFigureOut">
              <a:rPr kumimoji="1" lang="ja-JP" altLang="en-US" smtClean="0"/>
              <a:t>2024/2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A8FECE8-9B95-0B43-9BDF-B0C23A9352E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D7BCCEB-3D8D-9F4F-9F7E-E1BA84405B1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84CB2B-2296-D243-A6D7-AE7DEE240A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4839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69E4967-EC89-9145-86AC-71D844C898F8}"/>
              </a:ext>
            </a:extLst>
          </p:cNvPr>
          <p:cNvSpPr txBox="1"/>
          <p:nvPr/>
        </p:nvSpPr>
        <p:spPr>
          <a:xfrm rot="16200000">
            <a:off x="2498153" y="1378518"/>
            <a:ext cx="5838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kumimoji="1" lang="ja-JP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D8C046E-4AC3-714E-A5B5-AF76C182349F}"/>
              </a:ext>
            </a:extLst>
          </p:cNvPr>
          <p:cNvSpPr txBox="1"/>
          <p:nvPr/>
        </p:nvSpPr>
        <p:spPr>
          <a:xfrm rot="16200000">
            <a:off x="3070189" y="1363290"/>
            <a:ext cx="5533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II-4</a:t>
            </a:r>
            <a:endParaRPr kumimoji="1" lang="ja-JP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E8F4CE0-274E-B247-8A63-DE4167405D11}"/>
              </a:ext>
            </a:extLst>
          </p:cNvPr>
          <p:cNvSpPr txBox="1"/>
          <p:nvPr/>
        </p:nvSpPr>
        <p:spPr>
          <a:xfrm rot="16200000">
            <a:off x="3576317" y="1398556"/>
            <a:ext cx="62389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III-4</a:t>
            </a:r>
            <a:endParaRPr kumimoji="1" lang="ja-JP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79ECF21-8D5B-324F-AF95-F8A262E1B96C}"/>
              </a:ext>
            </a:extLst>
          </p:cNvPr>
          <p:cNvSpPr txBox="1"/>
          <p:nvPr/>
        </p:nvSpPr>
        <p:spPr>
          <a:xfrm rot="16200000">
            <a:off x="4076911" y="1406699"/>
            <a:ext cx="64017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IV-1</a:t>
            </a:r>
            <a:endParaRPr kumimoji="1" lang="ja-JP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64D02AC-4947-9F4D-A2EC-F172BB0087D4}"/>
              </a:ext>
            </a:extLst>
          </p:cNvPr>
          <p:cNvSpPr txBox="1"/>
          <p:nvPr/>
        </p:nvSpPr>
        <p:spPr>
          <a:xfrm>
            <a:off x="5141892" y="829642"/>
            <a:ext cx="95410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FHR3</a:t>
            </a:r>
          </a:p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52kD)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線矢印コネクタ 8">
            <a:extLst>
              <a:ext uri="{FF2B5EF4-FFF2-40B4-BE49-F238E27FC236}">
                <a16:creationId xmlns:a16="http://schemas.microsoft.com/office/drawing/2014/main" id="{88834D4D-C812-6E42-AF86-D22148820AF2}"/>
              </a:ext>
            </a:extLst>
          </p:cNvPr>
          <p:cNvCxnSpPr/>
          <p:nvPr/>
        </p:nvCxnSpPr>
        <p:spPr>
          <a:xfrm flipH="1">
            <a:off x="4777062" y="1013762"/>
            <a:ext cx="395251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" name="図 9">
            <a:extLst>
              <a:ext uri="{FF2B5EF4-FFF2-40B4-BE49-F238E27FC236}">
                <a16:creationId xmlns:a16="http://schemas.microsoft.com/office/drawing/2014/main" id="{58DE2351-E1E0-F449-A832-7BF591E6C2D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011" t="47032" r="33882" b="44540"/>
          <a:stretch/>
        </p:blipFill>
        <p:spPr>
          <a:xfrm>
            <a:off x="2554917" y="824381"/>
            <a:ext cx="2094671" cy="49193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E228E54B-5A65-AD4D-9ABB-CB6F6B594F2A}"/>
              </a:ext>
            </a:extLst>
          </p:cNvPr>
          <p:cNvSpPr txBox="1"/>
          <p:nvPr/>
        </p:nvSpPr>
        <p:spPr>
          <a:xfrm rot="16200000">
            <a:off x="8331025" y="5065214"/>
            <a:ext cx="5838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kumimoji="1" lang="ja-JP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878B4FF-1DFC-8041-8447-DDDE7611BF11}"/>
              </a:ext>
            </a:extLst>
          </p:cNvPr>
          <p:cNvSpPr txBox="1"/>
          <p:nvPr/>
        </p:nvSpPr>
        <p:spPr>
          <a:xfrm rot="16200000">
            <a:off x="8621711" y="5080442"/>
            <a:ext cx="5533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II-4</a:t>
            </a:r>
            <a:endParaRPr kumimoji="1" lang="ja-JP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D6BA6D3-E14D-494D-98F1-44591773C797}"/>
              </a:ext>
            </a:extLst>
          </p:cNvPr>
          <p:cNvSpPr txBox="1"/>
          <p:nvPr/>
        </p:nvSpPr>
        <p:spPr>
          <a:xfrm rot="16200000">
            <a:off x="8878457" y="5045176"/>
            <a:ext cx="62389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III-4</a:t>
            </a:r>
            <a:endParaRPr kumimoji="1" lang="ja-JP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3D8E1B36-4BE3-A742-BEA7-5C0CDB36E5A4}"/>
              </a:ext>
            </a:extLst>
          </p:cNvPr>
          <p:cNvSpPr txBox="1"/>
          <p:nvPr/>
        </p:nvSpPr>
        <p:spPr>
          <a:xfrm rot="16200000">
            <a:off x="9123278" y="5037033"/>
            <a:ext cx="64017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IV-1</a:t>
            </a:r>
            <a:endParaRPr kumimoji="1" lang="ja-JP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直線矢印コネクタ 14">
            <a:extLst>
              <a:ext uri="{FF2B5EF4-FFF2-40B4-BE49-F238E27FC236}">
                <a16:creationId xmlns:a16="http://schemas.microsoft.com/office/drawing/2014/main" id="{E26AAE36-0EE4-EC43-9B2B-0418977E10DE}"/>
              </a:ext>
            </a:extLst>
          </p:cNvPr>
          <p:cNvCxnSpPr/>
          <p:nvPr/>
        </p:nvCxnSpPr>
        <p:spPr>
          <a:xfrm flipH="1">
            <a:off x="9643421" y="4199186"/>
            <a:ext cx="34529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矢印コネクタ 15">
            <a:extLst>
              <a:ext uri="{FF2B5EF4-FFF2-40B4-BE49-F238E27FC236}">
                <a16:creationId xmlns:a16="http://schemas.microsoft.com/office/drawing/2014/main" id="{66FE8EA7-82F5-5F49-B61D-5AC81E3CADD0}"/>
              </a:ext>
            </a:extLst>
          </p:cNvPr>
          <p:cNvCxnSpPr/>
          <p:nvPr/>
        </p:nvCxnSpPr>
        <p:spPr>
          <a:xfrm flipH="1">
            <a:off x="9643421" y="2980213"/>
            <a:ext cx="34529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3209833-6308-8A4C-8A04-3B9C38C92160}"/>
              </a:ext>
            </a:extLst>
          </p:cNvPr>
          <p:cNvSpPr txBox="1"/>
          <p:nvPr/>
        </p:nvSpPr>
        <p:spPr>
          <a:xfrm>
            <a:off x="9988719" y="4037618"/>
            <a:ext cx="12763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gG region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9B4C8083-659C-5C42-8FD7-EC72EAB3B973}"/>
              </a:ext>
            </a:extLst>
          </p:cNvPr>
          <p:cNvSpPr txBox="1"/>
          <p:nvPr/>
        </p:nvSpPr>
        <p:spPr>
          <a:xfrm>
            <a:off x="9988719" y="2820832"/>
            <a:ext cx="17876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lbumin region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E30ECCD3-891B-F745-9B51-4C7E8089D9DE}"/>
              </a:ext>
            </a:extLst>
          </p:cNvPr>
          <p:cNvSpPr txBox="1"/>
          <p:nvPr/>
        </p:nvSpPr>
        <p:spPr>
          <a:xfrm>
            <a:off x="8039276" y="2451500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0C41F087-8B42-4549-B2B6-1C806439E989}"/>
              </a:ext>
            </a:extLst>
          </p:cNvPr>
          <p:cNvSpPr txBox="1"/>
          <p:nvPr/>
        </p:nvSpPr>
        <p:spPr>
          <a:xfrm>
            <a:off x="8039276" y="2900968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1826DBE6-502B-674A-BFCA-42014CAA1D1C}"/>
              </a:ext>
            </a:extLst>
          </p:cNvPr>
          <p:cNvSpPr txBox="1"/>
          <p:nvPr/>
        </p:nvSpPr>
        <p:spPr>
          <a:xfrm>
            <a:off x="8039276" y="3222902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28AF390D-51EE-0C43-9420-C6D4AC448C32}"/>
              </a:ext>
            </a:extLst>
          </p:cNvPr>
          <p:cNvSpPr txBox="1"/>
          <p:nvPr/>
        </p:nvSpPr>
        <p:spPr>
          <a:xfrm>
            <a:off x="8062606" y="3800506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F1AFCC5D-B8F5-4A4B-91B2-6703824CC4AF}"/>
              </a:ext>
            </a:extLst>
          </p:cNvPr>
          <p:cNvSpPr txBox="1"/>
          <p:nvPr/>
        </p:nvSpPr>
        <p:spPr>
          <a:xfrm>
            <a:off x="8062606" y="4099361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FE9FAB36-0A03-C845-B044-C8662D99140D}"/>
              </a:ext>
            </a:extLst>
          </p:cNvPr>
          <p:cNvSpPr txBox="1"/>
          <p:nvPr/>
        </p:nvSpPr>
        <p:spPr>
          <a:xfrm>
            <a:off x="8062606" y="4591616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2D1DF051-5FD3-C04E-B1D7-AD5C631A1D6E}"/>
              </a:ext>
            </a:extLst>
          </p:cNvPr>
          <p:cNvSpPr txBox="1"/>
          <p:nvPr/>
        </p:nvSpPr>
        <p:spPr>
          <a:xfrm>
            <a:off x="7934365" y="1786320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70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図 25">
            <a:extLst>
              <a:ext uri="{FF2B5EF4-FFF2-40B4-BE49-F238E27FC236}">
                <a16:creationId xmlns:a16="http://schemas.microsoft.com/office/drawing/2014/main" id="{9E72B8A1-C907-C64B-8FA8-49F084B3382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44" r="61632"/>
          <a:stretch/>
        </p:blipFill>
        <p:spPr>
          <a:xfrm>
            <a:off x="8504633" y="824381"/>
            <a:ext cx="1048844" cy="415317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36F51E47-F1A8-9141-97DD-C135FB8E5262}"/>
              </a:ext>
            </a:extLst>
          </p:cNvPr>
          <p:cNvSpPr txBox="1"/>
          <p:nvPr/>
        </p:nvSpPr>
        <p:spPr>
          <a:xfrm>
            <a:off x="415612" y="2684802"/>
            <a:ext cx="7056743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ja-JP" dirty="0"/>
              <a:t>CFHR3 protein amount analysis.</a:t>
            </a:r>
          </a:p>
          <a:p>
            <a:endParaRPr kumimoji="1" lang="en" altLang="ja-JP" dirty="0"/>
          </a:p>
          <a:p>
            <a:r>
              <a:rPr kumimoji="1" lang="en" altLang="ja-JP" dirty="0"/>
              <a:t>1</a:t>
            </a:r>
            <a:r>
              <a:rPr kumimoji="1" lang="el-GR" altLang="ja-JP" dirty="0"/>
              <a:t>μ</a:t>
            </a:r>
            <a:r>
              <a:rPr kumimoji="1" lang="en" altLang="ja-JP" dirty="0"/>
              <a:t>L of plasma from control person and family members who carry the CFH::CFHR1 fusion gene and CFHR3-1-4-2 genes duplication (Ⅱ-4, Ⅲ-4, and Ⅳ-1) were separated on 12 % SDS-PAGE and transferred to nitrocellulose membrane. In addition, Coomassie staining (Rt figure) confirmed equal protein amounts in each individual sample. CFHR3 protein was stained using CFHR3 polyclonal antibody (</a:t>
            </a:r>
            <a:r>
              <a:rPr kumimoji="1" lang="en" altLang="ja-JP" dirty="0" err="1"/>
              <a:t>proteintech</a:t>
            </a:r>
            <a:r>
              <a:rPr kumimoji="1" lang="en" altLang="ja-JP" dirty="0"/>
              <a:t>; Rosemont, IL, USA).</a:t>
            </a:r>
          </a:p>
          <a:p>
            <a:endParaRPr kumimoji="1" lang="en" altLang="ja-JP" dirty="0"/>
          </a:p>
          <a:p>
            <a:r>
              <a:rPr kumimoji="1" lang="en" altLang="ja-JP" dirty="0"/>
              <a:t>The densities of the band of CFHR3 in the family members are more pronounced than the densities in the control plasma.</a:t>
            </a:r>
          </a:p>
          <a:p>
            <a:endParaRPr kumimoji="1" lang="en" altLang="ja-JP" dirty="0"/>
          </a:p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69688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28</Words>
  <Application>Microsoft Macintosh PowerPoint</Application>
  <PresentationFormat>ワイド画面</PresentationFormat>
  <Paragraphs>2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okoyama Tadafumi</dc:creator>
  <cp:lastModifiedBy>Yokoyama Tadafumi</cp:lastModifiedBy>
  <cp:revision>2</cp:revision>
  <dcterms:created xsi:type="dcterms:W3CDTF">2024-02-03T11:42:24Z</dcterms:created>
  <dcterms:modified xsi:type="dcterms:W3CDTF">2024-02-10T12:57:34Z</dcterms:modified>
</cp:coreProperties>
</file>